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EA85B"/>
    <a:srgbClr val="48FF7D"/>
    <a:srgbClr val="467345"/>
    <a:srgbClr val="6F98A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82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CD5D9E-398A-DDD4-8A70-8C8EFBE889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91083FF-3A12-E028-4338-8686446366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D3D392-838B-3B36-A215-A74E15E74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9FD38-785A-4E3E-87B7-74E8FDBBF845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B580C7-E228-DC05-1C27-26A87127C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586173-0B8A-C84E-5856-0E85DB9945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2A99-E872-460F-B249-C9EFEB99EE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628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99CF52-BCA4-DD5F-7661-88FF00B61B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C9F61F-0F0C-9706-ABC0-67E35E6524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BEFBE0-FCB3-71EE-0A2E-AD12A92FF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9FD38-785A-4E3E-87B7-74E8FDBBF845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587E56-02B6-D94C-A56F-52C975540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55A716-78A2-47A3-54DB-27C8EE7E6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2A99-E872-460F-B249-C9EFEB99EE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871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7C9353D-C549-86CD-06D1-955AC8674A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591E57-A258-7F96-9D90-2BFC85582A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186BA7-7480-96AC-4753-DC704C0DB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9FD38-785A-4E3E-87B7-74E8FDBBF845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A4078C-4B95-30A5-F326-8780E40FD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28C249-EFDF-D393-D92D-6C31F8AEB4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2A99-E872-460F-B249-C9EFEB99EE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211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8A0155-2C9E-B082-1984-3E6B8BA91C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E36739-D898-64D2-E7DE-945634975F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7A50EF-79D2-B255-F3B3-97A0BAFEA0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9FD38-785A-4E3E-87B7-74E8FDBBF845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6987E1-8557-A669-B569-8B10901CDF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8A7771-08CF-B6F7-F04C-93BA2BF897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2A99-E872-460F-B249-C9EFEB99EE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724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288B72-B461-12F9-1BBE-779E12CCF2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6DE83F-6508-7914-148F-611FA81039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E4F654-A379-0CFE-DA2A-A2A1AFA338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9FD38-785A-4E3E-87B7-74E8FDBBF845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8BD085-CB80-0FE8-4B7B-DCF844600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B8266C-F6F0-0B76-0EDC-DAF2EB528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2A99-E872-460F-B249-C9EFEB99EE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6617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B3A684-47A0-D593-1E0E-D18F169B97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157A54-DFF1-5582-3325-3370E1BD86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BA0CD1-8B43-9F52-CC90-1BE693290E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F3C243-A31A-3CC6-5BF6-78AECD5DB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9FD38-785A-4E3E-87B7-74E8FDBBF845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7C187B-27BE-7E6E-48B9-8A2D5CE126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CE278B-811D-8318-831F-F7FB01D02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2A99-E872-460F-B249-C9EFEB99EE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6444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6E48B9-881F-C337-9E33-581C651546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EAF37E-309F-DB9E-0383-5BBCFD2E5F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93A109-EB8C-F269-9C36-57939183C6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D768E44-000F-8A1A-E876-9516642D98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444DC3E-B426-4252-2D05-99D3A89225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9E87409-9A69-4BF7-53F8-94A721BD5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9FD38-785A-4E3E-87B7-74E8FDBBF845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2D30E67-5D32-E4DC-D1D1-0C300F9371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99A35B8-9C14-05F4-A469-499189C2C7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2A99-E872-460F-B249-C9EFEB99EE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616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9526E8-2FD4-B0E5-3420-017FEDD673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26F5F5F-FCAE-99E8-7C32-92F4BF833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9FD38-785A-4E3E-87B7-74E8FDBBF845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FD6A43-14DA-4A4B-ACC2-34BF98EDE9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12368BE-2DD0-175D-92E5-84DDFC9B9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2A99-E872-460F-B249-C9EFEB99EE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383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3FE4226-E3F7-F6EB-9E29-4DB051F506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9FD38-785A-4E3E-87B7-74E8FDBBF845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2F76641-1DDC-A04B-427F-43028BF669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FAC34A-0CE0-CADF-BAB7-09D900C0BF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2A99-E872-460F-B249-C9EFEB99EE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38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C5623A-5ACC-9FA9-8BE9-99F7CB1508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68D2A8-126D-5706-956F-9B5831BB09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86CA75-B982-05FC-1E48-2321AE9B49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A9E491-A2E6-6F37-F16A-64B489B9E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9FD38-785A-4E3E-87B7-74E8FDBBF845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2F9F1B-460B-A12D-018D-28AEF3D08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072FE6-10CF-A3ED-B8B4-3DA515E7F9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2A99-E872-460F-B249-C9EFEB99EE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12273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E074F2-183D-29C1-E896-3C80F2C63A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84C8C8E-EAF0-12DC-3579-9D067056F9D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1AC670-DBDE-8ACE-A18F-E76D72557F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249ED3-8073-6E18-9E7B-E13B60230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9FD38-785A-4E3E-87B7-74E8FDBBF845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82B4D7-BB1F-213C-0034-93862A9CF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FAE5C9-09C1-4878-8D46-11A47EFB2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82A99-E872-460F-B249-C9EFEB99EE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8524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D83DF80-E181-C8B8-C4F3-55B1286C9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173892-1F60-A13E-7A57-20D6F74D8E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FC75D8-EFEA-0EC8-9093-577FFDDB1A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E9FD38-785A-4E3E-87B7-74E8FDBBF845}" type="datetimeFigureOut">
              <a:rPr lang="en-US" smtClean="0"/>
              <a:t>4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1C02A0-AA87-1755-24EA-BD1E7F7791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327D50-982C-898D-7E8E-0B45B7E2EC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B82A99-E872-460F-B249-C9EFEB99EE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876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8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svg"/><Relationship Id="rId5" Type="http://schemas.openxmlformats.org/officeDocument/2006/relationships/image" Target="../media/image7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6904D314-230D-7874-89DD-459B938119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71738" y="1862638"/>
            <a:ext cx="2557734" cy="242260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DD79C3C-73F3-FC16-11E5-80B094035F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76987" y="1865897"/>
            <a:ext cx="2505075" cy="2419350"/>
          </a:xfrm>
          <a:prstGeom prst="rect">
            <a:avLst/>
          </a:prstGeom>
        </p:spPr>
      </p:pic>
      <p:sp>
        <p:nvSpPr>
          <p:cNvPr id="10" name="Arrow: Right 9">
            <a:extLst>
              <a:ext uri="{FF2B5EF4-FFF2-40B4-BE49-F238E27FC236}">
                <a16:creationId xmlns:a16="http://schemas.microsoft.com/office/drawing/2014/main" id="{47EDDC1A-B33A-757E-EE38-0A6A32401968}"/>
              </a:ext>
            </a:extLst>
          </p:cNvPr>
          <p:cNvSpPr/>
          <p:nvPr/>
        </p:nvSpPr>
        <p:spPr>
          <a:xfrm>
            <a:off x="5457825" y="2905125"/>
            <a:ext cx="561975" cy="32385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193B3EE-BBCC-41F4-25B8-15E075EBDB70}"/>
              </a:ext>
            </a:extLst>
          </p:cNvPr>
          <p:cNvSpPr txBox="1"/>
          <p:nvPr/>
        </p:nvSpPr>
        <p:spPr>
          <a:xfrm>
            <a:off x="2124075" y="1181100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8B8A3E5-DEB4-F64A-1EB5-BC594EDCE4B8}"/>
              </a:ext>
            </a:extLst>
          </p:cNvPr>
          <p:cNvSpPr txBox="1"/>
          <p:nvPr/>
        </p:nvSpPr>
        <p:spPr>
          <a:xfrm>
            <a:off x="6067425" y="1181100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922985E-FB08-B5EA-F6FC-32DAADDDE202}"/>
              </a:ext>
            </a:extLst>
          </p:cNvPr>
          <p:cNvSpPr txBox="1"/>
          <p:nvPr/>
        </p:nvSpPr>
        <p:spPr>
          <a:xfrm>
            <a:off x="1133475" y="4686300"/>
            <a:ext cx="9429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1.</a:t>
            </a:r>
            <a:r>
              <a:rPr lang="en-US" sz="1400" dirty="0"/>
              <a:t> Discrimination of cells and other DNA negative material in lung tissue single cell suspension. </a:t>
            </a:r>
            <a:r>
              <a:rPr lang="en-US" sz="1400" b="1" dirty="0"/>
              <a:t>a)</a:t>
            </a:r>
            <a:r>
              <a:rPr lang="en-US" sz="1400" dirty="0"/>
              <a:t> Non stained sample and PI+ positive control. </a:t>
            </a:r>
            <a:r>
              <a:rPr lang="en-US" sz="1400" b="1" dirty="0"/>
              <a:t>b)</a:t>
            </a:r>
            <a:r>
              <a:rPr lang="en-US" sz="1400" dirty="0"/>
              <a:t> Position of PI+ cells (blue) on scatter plot.</a:t>
            </a:r>
          </a:p>
        </p:txBody>
      </p:sp>
    </p:spTree>
    <p:extLst>
      <p:ext uri="{BB962C8B-B14F-4D97-AF65-F5344CB8AC3E}">
        <p14:creationId xmlns:p14="http://schemas.microsoft.com/office/powerpoint/2010/main" val="40966125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F195FA8-743F-0E1C-A3C8-8C78A13D091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489" t="685" r="2944" b="1968"/>
          <a:stretch/>
        </p:blipFill>
        <p:spPr>
          <a:xfrm>
            <a:off x="336881" y="235237"/>
            <a:ext cx="2884903" cy="279557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9B8DFC9-813C-2126-DEA9-D79D6C04CC9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64" t="1748" r="1755" b="1773"/>
          <a:stretch/>
        </p:blipFill>
        <p:spPr>
          <a:xfrm>
            <a:off x="3862467" y="257175"/>
            <a:ext cx="2967224" cy="277363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7D394A4-3BA7-1616-C439-716635C9156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91" t="873" r="811" b="2547"/>
          <a:stretch/>
        </p:blipFill>
        <p:spPr>
          <a:xfrm>
            <a:off x="7908615" y="161924"/>
            <a:ext cx="3027860" cy="302310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3E5DE02-4595-905F-187A-7939F6D803D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078" t="2521" r="2431" b="1759"/>
          <a:stretch/>
        </p:blipFill>
        <p:spPr>
          <a:xfrm>
            <a:off x="4067094" y="3724938"/>
            <a:ext cx="2809875" cy="2799015"/>
          </a:xfrm>
          <a:prstGeom prst="rect">
            <a:avLst/>
          </a:prstGeom>
        </p:spPr>
      </p:pic>
      <p:pic>
        <p:nvPicPr>
          <p:cNvPr id="13" name="Graphic 12">
            <a:extLst>
              <a:ext uri="{FF2B5EF4-FFF2-40B4-BE49-F238E27FC236}">
                <a16:creationId xmlns:a16="http://schemas.microsoft.com/office/drawing/2014/main" id="{009A1031-3A13-5B60-F184-4A8259D8302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rcRect t="-449" b="-1"/>
          <a:stretch/>
        </p:blipFill>
        <p:spPr>
          <a:xfrm>
            <a:off x="7869970" y="3672972"/>
            <a:ext cx="3105150" cy="2899025"/>
          </a:xfrm>
          <a:prstGeom prst="rect">
            <a:avLst/>
          </a:prstGeom>
        </p:spPr>
      </p:pic>
      <p:sp>
        <p:nvSpPr>
          <p:cNvPr id="14" name="Arrow: Down 13">
            <a:extLst>
              <a:ext uri="{FF2B5EF4-FFF2-40B4-BE49-F238E27FC236}">
                <a16:creationId xmlns:a16="http://schemas.microsoft.com/office/drawing/2014/main" id="{40229A11-A6B2-4E90-DC87-A58627DAB53A}"/>
              </a:ext>
            </a:extLst>
          </p:cNvPr>
          <p:cNvSpPr/>
          <p:nvPr/>
        </p:nvSpPr>
        <p:spPr>
          <a:xfrm rot="16200000">
            <a:off x="3405959" y="1381938"/>
            <a:ext cx="325106" cy="448303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row: Down 14">
            <a:extLst>
              <a:ext uri="{FF2B5EF4-FFF2-40B4-BE49-F238E27FC236}">
                <a16:creationId xmlns:a16="http://schemas.microsoft.com/office/drawing/2014/main" id="{D7C4E864-837D-A764-F9B5-00388167DE36}"/>
              </a:ext>
            </a:extLst>
          </p:cNvPr>
          <p:cNvSpPr/>
          <p:nvPr/>
        </p:nvSpPr>
        <p:spPr>
          <a:xfrm rot="16200000">
            <a:off x="7138202" y="1482190"/>
            <a:ext cx="325106" cy="448303"/>
          </a:xfrm>
          <a:prstGeom prst="downArrow">
            <a:avLst/>
          </a:prstGeom>
          <a:solidFill>
            <a:srgbClr val="6F98AC"/>
          </a:solidFill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F8507AC-AC15-B86D-3569-8409F63049CD}"/>
              </a:ext>
            </a:extLst>
          </p:cNvPr>
          <p:cNvSpPr txBox="1"/>
          <p:nvPr/>
        </p:nvSpPr>
        <p:spPr>
          <a:xfrm>
            <a:off x="6748160" y="1881426"/>
            <a:ext cx="1160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6F98AC"/>
                </a:solidFill>
              </a:rPr>
              <a:t>GFP+ </a:t>
            </a:r>
            <a:r>
              <a:rPr lang="en-US" dirty="0" err="1">
                <a:solidFill>
                  <a:srgbClr val="6F98AC"/>
                </a:solidFill>
              </a:rPr>
              <a:t>AFhi</a:t>
            </a:r>
            <a:endParaRPr lang="en-US" dirty="0">
              <a:solidFill>
                <a:srgbClr val="6F98AC"/>
              </a:solidFill>
            </a:endParaRPr>
          </a:p>
        </p:txBody>
      </p:sp>
      <p:sp>
        <p:nvSpPr>
          <p:cNvPr id="17" name="Arrow: Down 16">
            <a:extLst>
              <a:ext uri="{FF2B5EF4-FFF2-40B4-BE49-F238E27FC236}">
                <a16:creationId xmlns:a16="http://schemas.microsoft.com/office/drawing/2014/main" id="{8B00F3F4-72EC-D5AB-6B38-AB2653C05AFB}"/>
              </a:ext>
            </a:extLst>
          </p:cNvPr>
          <p:cNvSpPr/>
          <p:nvPr/>
        </p:nvSpPr>
        <p:spPr>
          <a:xfrm>
            <a:off x="5146926" y="3087226"/>
            <a:ext cx="325106" cy="448303"/>
          </a:xfrm>
          <a:prstGeom prst="downArrow">
            <a:avLst/>
          </a:prstGeom>
          <a:solidFill>
            <a:srgbClr val="467345"/>
          </a:solidFill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2B139D3-E35E-AE87-C728-87045293B002}"/>
              </a:ext>
            </a:extLst>
          </p:cNvPr>
          <p:cNvSpPr txBox="1"/>
          <p:nvPr/>
        </p:nvSpPr>
        <p:spPr>
          <a:xfrm>
            <a:off x="5515772" y="3092484"/>
            <a:ext cx="15608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467345"/>
                </a:solidFill>
              </a:rPr>
              <a:t>GFP+ </a:t>
            </a:r>
            <a:r>
              <a:rPr lang="en-US" dirty="0" err="1">
                <a:solidFill>
                  <a:srgbClr val="467345"/>
                </a:solidFill>
              </a:rPr>
              <a:t>AFlow</a:t>
            </a:r>
            <a:endParaRPr lang="en-US" dirty="0">
              <a:solidFill>
                <a:srgbClr val="467345"/>
              </a:solidFill>
            </a:endParaRPr>
          </a:p>
        </p:txBody>
      </p:sp>
      <p:sp>
        <p:nvSpPr>
          <p:cNvPr id="19" name="Arrow: Down 18">
            <a:extLst>
              <a:ext uri="{FF2B5EF4-FFF2-40B4-BE49-F238E27FC236}">
                <a16:creationId xmlns:a16="http://schemas.microsoft.com/office/drawing/2014/main" id="{D024D77B-0DB7-2BEE-E2F3-B0D808757A69}"/>
              </a:ext>
            </a:extLst>
          </p:cNvPr>
          <p:cNvSpPr/>
          <p:nvPr/>
        </p:nvSpPr>
        <p:spPr>
          <a:xfrm>
            <a:off x="9246653" y="3146444"/>
            <a:ext cx="325106" cy="448303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Arrow: Down 19">
            <a:extLst>
              <a:ext uri="{FF2B5EF4-FFF2-40B4-BE49-F238E27FC236}">
                <a16:creationId xmlns:a16="http://schemas.microsoft.com/office/drawing/2014/main" id="{54B13239-8039-75E4-A329-E171D8726FEF}"/>
              </a:ext>
            </a:extLst>
          </p:cNvPr>
          <p:cNvSpPr/>
          <p:nvPr/>
        </p:nvSpPr>
        <p:spPr>
          <a:xfrm rot="16200000">
            <a:off x="7127025" y="4900295"/>
            <a:ext cx="325106" cy="448303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117DC6F-00C0-CA86-EBAB-DC891D140F32}"/>
              </a:ext>
            </a:extLst>
          </p:cNvPr>
          <p:cNvSpPr txBox="1"/>
          <p:nvPr/>
        </p:nvSpPr>
        <p:spPr>
          <a:xfrm>
            <a:off x="98431" y="257175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63A491B-5F57-E9D2-F28E-056C81303BC3}"/>
              </a:ext>
            </a:extLst>
          </p:cNvPr>
          <p:cNvSpPr txBox="1"/>
          <p:nvPr/>
        </p:nvSpPr>
        <p:spPr>
          <a:xfrm>
            <a:off x="3792664" y="235237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45726AC-59CA-4D22-AD93-B677525A4614}"/>
              </a:ext>
            </a:extLst>
          </p:cNvPr>
          <p:cNvSpPr txBox="1"/>
          <p:nvPr/>
        </p:nvSpPr>
        <p:spPr>
          <a:xfrm>
            <a:off x="7631845" y="235237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77690C2-47C2-CA7A-1890-CD96173F8752}"/>
              </a:ext>
            </a:extLst>
          </p:cNvPr>
          <p:cNvSpPr txBox="1"/>
          <p:nvPr/>
        </p:nvSpPr>
        <p:spPr>
          <a:xfrm>
            <a:off x="3792664" y="3332292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93A0DFD-65B7-33ED-FC02-410B42FFBBE9}"/>
              </a:ext>
            </a:extLst>
          </p:cNvPr>
          <p:cNvSpPr txBox="1"/>
          <p:nvPr/>
        </p:nvSpPr>
        <p:spPr>
          <a:xfrm>
            <a:off x="7670490" y="3287826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03F45C4-A152-A9DF-B6A1-6D43932F1EF0}"/>
              </a:ext>
            </a:extLst>
          </p:cNvPr>
          <p:cNvSpPr txBox="1"/>
          <p:nvPr/>
        </p:nvSpPr>
        <p:spPr>
          <a:xfrm>
            <a:off x="127396" y="3287826"/>
            <a:ext cx="3621528" cy="32316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 cont’d.</a:t>
            </a:r>
            <a:r>
              <a:rPr lang="en-US" sz="1200" dirty="0"/>
              <a:t>, analysis of metastatic cells in lungs. </a:t>
            </a:r>
            <a:r>
              <a:rPr lang="en-US" sz="1200" b="1" dirty="0"/>
              <a:t>c)</a:t>
            </a:r>
            <a:r>
              <a:rPr lang="en-US" sz="1200" dirty="0"/>
              <a:t> gating of cells based on scatter gates; </a:t>
            </a:r>
            <a:r>
              <a:rPr lang="en-US" sz="1200" b="1" dirty="0"/>
              <a:t>d)</a:t>
            </a:r>
            <a:r>
              <a:rPr lang="en-US" sz="1200" dirty="0"/>
              <a:t> gating of GFP+ cells with high and low autofluorescence (AF) based on FMO gates, orange events are non-stained samples which are depicted for illustrative purposes; </a:t>
            </a:r>
            <a:r>
              <a:rPr lang="en-US" sz="1200" b="1" dirty="0"/>
              <a:t>e)</a:t>
            </a:r>
            <a:r>
              <a:rPr lang="en-US" sz="1200" dirty="0"/>
              <a:t> final gate for metastatic cell quantification in “GFP+AF hi” gates, final gate were drawn based on maximum difference method in comparison to healthy mice (i.e., biological control); </a:t>
            </a:r>
            <a:r>
              <a:rPr lang="en-US" sz="1200" b="1" dirty="0"/>
              <a:t>f)</a:t>
            </a:r>
            <a:r>
              <a:rPr lang="en-US" sz="1200" dirty="0"/>
              <a:t> final gate for metastatic cell quantification in “GFP+ AF low” gates, final gate were drawn based on percentile </a:t>
            </a:r>
            <a:r>
              <a:rPr lang="en-US" sz="1200"/>
              <a:t>by percentile </a:t>
            </a:r>
            <a:r>
              <a:rPr lang="en-US" sz="1200" dirty="0"/>
              <a:t>subtraction method in comparison to healthy mice (i.e., biological control); </a:t>
            </a:r>
            <a:r>
              <a:rPr lang="en-US" sz="1200" b="1" dirty="0"/>
              <a:t>g)</a:t>
            </a:r>
            <a:r>
              <a:rPr lang="en-US" sz="1200" dirty="0"/>
              <a:t> Ki-67 and aCasp3 gates for metastatic cells. Metastatic load for statistical analysis was quantified as a sum of cells in  both </a:t>
            </a:r>
            <a:r>
              <a:rPr lang="en-US" sz="1200" dirty="0">
                <a:solidFill>
                  <a:srgbClr val="48FF7D"/>
                </a:solidFill>
              </a:rPr>
              <a:t>“GFP+ metastatic cells”</a:t>
            </a:r>
            <a:r>
              <a:rPr lang="en-US" sz="1200" dirty="0"/>
              <a:t> gates and expressed as % of “Cells” gate. For more details see the Methods section.</a:t>
            </a:r>
          </a:p>
        </p:txBody>
      </p:sp>
    </p:spTree>
    <p:extLst>
      <p:ext uri="{BB962C8B-B14F-4D97-AF65-F5344CB8AC3E}">
        <p14:creationId xmlns:p14="http://schemas.microsoft.com/office/powerpoint/2010/main" val="37302643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FD0E59C-A6F5-33FC-4494-ADC3F7960E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0286" y="2130964"/>
            <a:ext cx="2641826" cy="266963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07DDBCB-568D-6DB7-6E40-55CA9FEB8D0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93315" y="2130964"/>
            <a:ext cx="2679035" cy="266963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AA7C8B5-E6D2-0553-D72A-A66DD172C4E3}"/>
              </a:ext>
            </a:extLst>
          </p:cNvPr>
          <p:cNvSpPr txBox="1"/>
          <p:nvPr/>
        </p:nvSpPr>
        <p:spPr>
          <a:xfrm>
            <a:off x="2162175" y="1761632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9679A70-B4F1-97A7-2B04-AE2B5A679D48}"/>
              </a:ext>
            </a:extLst>
          </p:cNvPr>
          <p:cNvSpPr txBox="1"/>
          <p:nvPr/>
        </p:nvSpPr>
        <p:spPr>
          <a:xfrm>
            <a:off x="6105525" y="1761632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411274-B01F-7E5B-3198-A4C5101C1C29}"/>
              </a:ext>
            </a:extLst>
          </p:cNvPr>
          <p:cNvSpPr txBox="1"/>
          <p:nvPr/>
        </p:nvSpPr>
        <p:spPr>
          <a:xfrm>
            <a:off x="1083811" y="5169931"/>
            <a:ext cx="9429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2.</a:t>
            </a:r>
            <a:r>
              <a:rPr lang="en-US" sz="1400" dirty="0"/>
              <a:t> Discrimination of cells and other DNA negative material in </a:t>
            </a:r>
            <a:r>
              <a:rPr lang="el-GR" sz="1400" dirty="0"/>
              <a:t>ε</a:t>
            </a:r>
            <a:r>
              <a:rPr lang="en-US" sz="1400" dirty="0"/>
              <a:t>-PLC implant single cell suspension. </a:t>
            </a:r>
            <a:r>
              <a:rPr lang="en-US" sz="1400" b="1" dirty="0"/>
              <a:t>a)</a:t>
            </a:r>
            <a:r>
              <a:rPr lang="en-US" sz="1400" dirty="0"/>
              <a:t> Non stained sample and PI+ positive control. </a:t>
            </a:r>
            <a:r>
              <a:rPr lang="en-US" sz="1400" b="1" dirty="0"/>
              <a:t>b)</a:t>
            </a:r>
            <a:r>
              <a:rPr lang="en-US" sz="1400" dirty="0"/>
              <a:t> Position of PI+ cells (red events) on scatter plot.</a:t>
            </a:r>
          </a:p>
        </p:txBody>
      </p:sp>
    </p:spTree>
    <p:extLst>
      <p:ext uri="{BB962C8B-B14F-4D97-AF65-F5344CB8AC3E}">
        <p14:creationId xmlns:p14="http://schemas.microsoft.com/office/powerpoint/2010/main" val="33623905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CE01B2D-4EFA-DC6C-F58D-8FAECAB1B8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736" y="766455"/>
            <a:ext cx="2647950" cy="244792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EB914EE-D5C6-5F75-73E6-D748E3CA2A7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311" t="1966" r="3137" b="3447"/>
          <a:stretch/>
        </p:blipFill>
        <p:spPr>
          <a:xfrm>
            <a:off x="3326266" y="1006260"/>
            <a:ext cx="2387970" cy="239756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A7A18A6-3877-0506-5407-04DDB8ED9C0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59989" y="874937"/>
            <a:ext cx="2662002" cy="2447925"/>
          </a:xfrm>
          <a:prstGeom prst="rect">
            <a:avLst/>
          </a:prstGeom>
        </p:spPr>
      </p:pic>
      <p:sp>
        <p:nvSpPr>
          <p:cNvPr id="10" name="Arrow: Right 9">
            <a:extLst>
              <a:ext uri="{FF2B5EF4-FFF2-40B4-BE49-F238E27FC236}">
                <a16:creationId xmlns:a16="http://schemas.microsoft.com/office/drawing/2014/main" id="{94098DA7-FA9F-D4D8-D3D0-A44C615170A1}"/>
              </a:ext>
            </a:extLst>
          </p:cNvPr>
          <p:cNvSpPr/>
          <p:nvPr/>
        </p:nvSpPr>
        <p:spPr>
          <a:xfrm>
            <a:off x="2715686" y="1919288"/>
            <a:ext cx="473564" cy="2381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Arrow: Right 10">
            <a:extLst>
              <a:ext uri="{FF2B5EF4-FFF2-40B4-BE49-F238E27FC236}">
                <a16:creationId xmlns:a16="http://schemas.microsoft.com/office/drawing/2014/main" id="{B38539D4-BB5C-1016-6DF8-B12250A1BADB}"/>
              </a:ext>
            </a:extLst>
          </p:cNvPr>
          <p:cNvSpPr/>
          <p:nvPr/>
        </p:nvSpPr>
        <p:spPr>
          <a:xfrm>
            <a:off x="5757818" y="1919288"/>
            <a:ext cx="392791" cy="2381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Arrow: Right 11">
            <a:extLst>
              <a:ext uri="{FF2B5EF4-FFF2-40B4-BE49-F238E27FC236}">
                <a16:creationId xmlns:a16="http://schemas.microsoft.com/office/drawing/2014/main" id="{207A703A-84B8-86D3-22C4-346B854C3CFD}"/>
              </a:ext>
            </a:extLst>
          </p:cNvPr>
          <p:cNvSpPr/>
          <p:nvPr/>
        </p:nvSpPr>
        <p:spPr>
          <a:xfrm>
            <a:off x="8982044" y="1913064"/>
            <a:ext cx="392791" cy="2381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4" name="Graphic 13">
            <a:extLst>
              <a:ext uri="{FF2B5EF4-FFF2-40B4-BE49-F238E27FC236}">
                <a16:creationId xmlns:a16="http://schemas.microsoft.com/office/drawing/2014/main" id="{FC7FD821-A673-CBAE-09D5-D5729AE42BB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9434889" y="766455"/>
            <a:ext cx="2723490" cy="2531342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FA798420-FA80-FDAA-629F-9B70C9AEED8E}"/>
              </a:ext>
            </a:extLst>
          </p:cNvPr>
          <p:cNvSpPr txBox="1"/>
          <p:nvPr/>
        </p:nvSpPr>
        <p:spPr>
          <a:xfrm>
            <a:off x="98431" y="257175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A569D3B-E3D4-E29B-47D5-A244A51C43D3}"/>
              </a:ext>
            </a:extLst>
          </p:cNvPr>
          <p:cNvSpPr txBox="1"/>
          <p:nvPr/>
        </p:nvSpPr>
        <p:spPr>
          <a:xfrm>
            <a:off x="3189250" y="261669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FE7D1B8-3E11-CD2B-DB29-12EF247D553A}"/>
              </a:ext>
            </a:extLst>
          </p:cNvPr>
          <p:cNvSpPr txBox="1"/>
          <p:nvPr/>
        </p:nvSpPr>
        <p:spPr>
          <a:xfrm>
            <a:off x="6041944" y="257175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045D385-21BB-BC45-4FA0-C1D98DC4DDEE}"/>
              </a:ext>
            </a:extLst>
          </p:cNvPr>
          <p:cNvSpPr txBox="1"/>
          <p:nvPr/>
        </p:nvSpPr>
        <p:spPr>
          <a:xfrm>
            <a:off x="9132763" y="257175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3CDB37F-475E-3E16-9580-3570F80D0161}"/>
              </a:ext>
            </a:extLst>
          </p:cNvPr>
          <p:cNvSpPr txBox="1"/>
          <p:nvPr/>
        </p:nvSpPr>
        <p:spPr>
          <a:xfrm>
            <a:off x="1698702" y="3875530"/>
            <a:ext cx="879459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2. cont’d. </a:t>
            </a:r>
            <a:r>
              <a:rPr lang="en-US" sz="1200" dirty="0"/>
              <a:t>Analysis of metastatic cells in </a:t>
            </a:r>
            <a:r>
              <a:rPr lang="el-GR" sz="1200" dirty="0"/>
              <a:t>ε</a:t>
            </a:r>
            <a:r>
              <a:rPr lang="en-US" sz="1200" dirty="0"/>
              <a:t>-PLC implants. </a:t>
            </a:r>
            <a:r>
              <a:rPr lang="en-US" sz="1200" b="1" dirty="0"/>
              <a:t>c)</a:t>
            </a:r>
            <a:r>
              <a:rPr lang="en-US" sz="1200" dirty="0"/>
              <a:t> gating of cells based on scatter gates (red events); </a:t>
            </a:r>
            <a:r>
              <a:rPr lang="en-US" sz="1200" b="1" dirty="0"/>
              <a:t>d) </a:t>
            </a:r>
            <a:r>
              <a:rPr lang="en-US" sz="1200" dirty="0"/>
              <a:t>cumulative probability plots for a sample (blue), healthy mouse (i.e., biological control, red) and non-stained sample (orange, dashed); </a:t>
            </a:r>
            <a:r>
              <a:rPr lang="en-US" sz="1200" b="1" dirty="0"/>
              <a:t>e)</a:t>
            </a:r>
            <a:r>
              <a:rPr lang="en-US" sz="1200" dirty="0"/>
              <a:t> final gate for metastatic cell quantification which was drawn by max. difference method between cumulative probability curves and grouping on FCS axis (biological control- red events, sample- blue events); </a:t>
            </a:r>
            <a:r>
              <a:rPr lang="en-US" sz="1200" b="1" dirty="0"/>
              <a:t>f)</a:t>
            </a:r>
            <a:r>
              <a:rPr lang="en-US" sz="1200" dirty="0"/>
              <a:t> Ki-67 and aCasp3 gates for metastatic cells.</a:t>
            </a:r>
          </a:p>
          <a:p>
            <a:r>
              <a:rPr lang="en-US" sz="1200" dirty="0"/>
              <a:t>Metastatic load for statistical analysis was </a:t>
            </a:r>
            <a:r>
              <a:rPr lang="en-US" sz="1200"/>
              <a:t>quantified as count </a:t>
            </a:r>
            <a:r>
              <a:rPr lang="en-US" sz="1200" dirty="0"/>
              <a:t>of cells in </a:t>
            </a:r>
            <a:r>
              <a:rPr lang="en-US" sz="1200" dirty="0">
                <a:solidFill>
                  <a:srgbClr val="6EA85B"/>
                </a:solidFill>
              </a:rPr>
              <a:t>“GFP+ metastatic cells”</a:t>
            </a:r>
            <a:r>
              <a:rPr lang="en-US" sz="1200" dirty="0"/>
              <a:t> gates and expressed as % of “Cells scatter gates” that are depicted here as red events on graph c. For more details see the Methods section.</a:t>
            </a:r>
          </a:p>
        </p:txBody>
      </p:sp>
    </p:spTree>
    <p:extLst>
      <p:ext uri="{BB962C8B-B14F-4D97-AF65-F5344CB8AC3E}">
        <p14:creationId xmlns:p14="http://schemas.microsoft.com/office/powerpoint/2010/main" val="16054458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9</TotalTime>
  <Words>455</Words>
  <Application>Microsoft Office PowerPoint</Application>
  <PresentationFormat>Widescreen</PresentationFormat>
  <Paragraphs>2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jamin Benzon</dc:creator>
  <cp:lastModifiedBy>Benjamin Benzon</cp:lastModifiedBy>
  <cp:revision>15</cp:revision>
  <dcterms:created xsi:type="dcterms:W3CDTF">2023-03-31T17:02:38Z</dcterms:created>
  <dcterms:modified xsi:type="dcterms:W3CDTF">2023-04-03T21:02:54Z</dcterms:modified>
</cp:coreProperties>
</file>